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1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82" autoAdjust="0"/>
    <p:restoredTop sz="94660"/>
  </p:normalViewPr>
  <p:slideViewPr>
    <p:cSldViewPr snapToGrid="0">
      <p:cViewPr varScale="1">
        <p:scale>
          <a:sx n="77" d="100"/>
          <a:sy n="77" d="100"/>
        </p:scale>
        <p:origin x="34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chemeClr val="tx1"/>
                </a:solidFill>
              </a:rPr>
              <a:t>Acetosyringone </a:t>
            </a:r>
            <a:r>
              <a:rPr lang="en-US" sz="1200" i="1">
                <a:solidFill>
                  <a:schemeClr val="tx1"/>
                </a:solidFill>
              </a:rPr>
              <a:t>(N. tabacum)</a:t>
            </a:r>
          </a:p>
        </c:rich>
      </c:tx>
      <c:layout>
        <c:manualLayout>
          <c:xMode val="edge"/>
          <c:yMode val="edge"/>
          <c:x val="0.24534498632697091"/>
          <c:y val="3.5080407294365075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458345357353891"/>
          <c:y val="0.16834490740740743"/>
          <c:w val="0.67821344967014263"/>
          <c:h val="0.56890447287839019"/>
        </c:manualLayout>
      </c:layout>
      <c:lineChart>
        <c:grouping val="standard"/>
        <c:varyColors val="0"/>
        <c:ser>
          <c:idx val="1"/>
          <c:order val="0"/>
          <c:tx>
            <c:strRef>
              <c:f>Munka2!$V$98</c:f>
              <c:strCache>
                <c:ptCount val="1"/>
                <c:pt idx="0">
                  <c:v>W 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Pt>
            <c:idx val="2"/>
            <c:bubble3D val="0"/>
            <c:spPr>
              <a:ln w="41275" cap="rnd">
                <a:solidFill>
                  <a:schemeClr val="accent2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C6C1-428E-A2DB-EB0EB24A94D3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Munka2!$X$99:$X$10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Munka2!$X$99:$X$10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Munka2!$U$99:$U$101</c:f>
              <c:numCache>
                <c:formatCode>General</c:formatCode>
                <c:ptCount val="3"/>
                <c:pt idx="0">
                  <c:v>2</c:v>
                </c:pt>
                <c:pt idx="1">
                  <c:v>4</c:v>
                </c:pt>
                <c:pt idx="2">
                  <c:v>6</c:v>
                </c:pt>
              </c:numCache>
            </c:numRef>
          </c:cat>
          <c:val>
            <c:numRef>
              <c:f>Munka2!$V$99:$V$101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6C1-428E-A2DB-EB0EB24A94D3}"/>
            </c:ext>
          </c:extLst>
        </c:ser>
        <c:ser>
          <c:idx val="0"/>
          <c:order val="1"/>
          <c:tx>
            <c:strRef>
              <c:f>Munka2!$W$98</c:f>
              <c:strCache>
                <c:ptCount val="1"/>
                <c:pt idx="0">
                  <c:v>P.s. syringae hrcC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unka2!$Y$99:$Y$101</c:f>
                <c:numCache>
                  <c:formatCode>General</c:formatCode>
                  <c:ptCount val="3"/>
                  <c:pt idx="0">
                    <c:v>2585.6666666666665</c:v>
                  </c:pt>
                  <c:pt idx="1">
                    <c:v>53640.5</c:v>
                  </c:pt>
                  <c:pt idx="2">
                    <c:v>68772.666666666672</c:v>
                  </c:pt>
                </c:numCache>
              </c:numRef>
            </c:plus>
            <c:minus>
              <c:numRef>
                <c:f>Munka2!$Y$99:$Y$101</c:f>
                <c:numCache>
                  <c:formatCode>General</c:formatCode>
                  <c:ptCount val="3"/>
                  <c:pt idx="0">
                    <c:v>2585.6666666666665</c:v>
                  </c:pt>
                  <c:pt idx="1">
                    <c:v>53640.5</c:v>
                  </c:pt>
                  <c:pt idx="2">
                    <c:v>68772.6666666666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Munka2!$U$99:$U$101</c:f>
              <c:numCache>
                <c:formatCode>General</c:formatCode>
                <c:ptCount val="3"/>
                <c:pt idx="0">
                  <c:v>2</c:v>
                </c:pt>
                <c:pt idx="1">
                  <c:v>4</c:v>
                </c:pt>
                <c:pt idx="2">
                  <c:v>6</c:v>
                </c:pt>
              </c:numCache>
            </c:numRef>
          </c:cat>
          <c:val>
            <c:numRef>
              <c:f>Munka2!$W$99:$W$101</c:f>
              <c:numCache>
                <c:formatCode>General</c:formatCode>
                <c:ptCount val="3"/>
                <c:pt idx="0">
                  <c:v>5171.333333333333</c:v>
                </c:pt>
                <c:pt idx="1">
                  <c:v>107281</c:v>
                </c:pt>
                <c:pt idx="2">
                  <c:v>137545.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6C1-428E-A2DB-EB0EB24A94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40287232"/>
        <c:axId val="341034112"/>
      </c:lineChart>
      <c:catAx>
        <c:axId val="2402872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900">
                    <a:solidFill>
                      <a:schemeClr val="tx1"/>
                    </a:solidFill>
                  </a:rPr>
                  <a:t>Time (hpi)</a:t>
                </a:r>
                <a:endParaRPr lang="hu-HU" sz="90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53456410578159796"/>
              <c:y val="0.8252023184601923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341034112"/>
        <c:crosses val="autoZero"/>
        <c:auto val="1"/>
        <c:lblAlgn val="ctr"/>
        <c:lblOffset val="100"/>
        <c:noMultiLvlLbl val="0"/>
      </c:catAx>
      <c:valAx>
        <c:axId val="3410341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900" dirty="0">
                    <a:solidFill>
                      <a:schemeClr val="tx1"/>
                    </a:solidFill>
                  </a:rPr>
                  <a:t>Relative abundance /Peak area/</a:t>
                </a:r>
                <a:endParaRPr lang="hu-HU" sz="9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7.753422714052635E-3"/>
              <c:y val="0.115834808108269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E+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24028723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4548824394332908"/>
          <c:y val="0.88744132960578614"/>
          <c:w val="0.58922655833359472"/>
          <c:h val="0.108508311461067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hu-HU"/>
        </a:p>
      </c:txPr>
    </c:legend>
    <c:plotVisOnly val="1"/>
    <c:dispBlanksAs val="gap"/>
    <c:showDLblsOverMax val="0"/>
  </c:chart>
  <c:spPr>
    <a:solidFill>
      <a:schemeClr val="bg1"/>
    </a:solidFill>
    <a:ln w="3175" cap="flat" cmpd="sng" algn="ctr">
      <a:solidFill>
        <a:srgbClr val="E7E6E6">
          <a:lumMod val="90000"/>
        </a:srgbClr>
      </a:solidFill>
      <a:round/>
    </a:ln>
    <a:effectLst/>
  </c:spPr>
  <c:txPr>
    <a:bodyPr/>
    <a:lstStyle/>
    <a:p>
      <a:pPr>
        <a:defRPr/>
      </a:pPr>
      <a:endParaRPr lang="hu-HU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3051</cdr:x>
      <cdr:y>0.29167</cdr:y>
    </cdr:from>
    <cdr:to>
      <cdr:x>0.60422</cdr:x>
      <cdr:y>0.375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1495714" y="682315"/>
          <a:ext cx="207818" cy="1949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100"/>
            <a:t>**</a:t>
          </a:r>
          <a:endParaRPr lang="hu-HU" sz="1100"/>
        </a:p>
      </cdr:txBody>
    </cdr:sp>
  </cdr:relSizeAnchor>
  <cdr:relSizeAnchor xmlns:cdr="http://schemas.openxmlformats.org/drawingml/2006/chartDrawing">
    <cdr:from>
      <cdr:x>0.86858</cdr:x>
      <cdr:y>0.1896</cdr:y>
    </cdr:from>
    <cdr:to>
      <cdr:x>0.94228</cdr:x>
      <cdr:y>0.27294</cdr:y>
    </cdr:to>
    <cdr:sp macro="" textlink="">
      <cdr:nvSpPr>
        <cdr:cNvPr id="3" name="Szövegdoboz 1"/>
        <cdr:cNvSpPr txBox="1"/>
      </cdr:nvSpPr>
      <cdr:spPr>
        <a:xfrm xmlns:a="http://schemas.openxmlformats.org/drawingml/2006/main">
          <a:off x="2448883" y="443533"/>
          <a:ext cx="207790" cy="1949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100"/>
            <a:t>**</a:t>
          </a:r>
          <a:endParaRPr lang="hu-HU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20359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9268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11378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04411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64867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39164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27928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89902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47919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91490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6278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0273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13" r:id="rId1"/>
    <p:sldLayoutId id="2147483914" r:id="rId2"/>
    <p:sldLayoutId id="2147483915" r:id="rId3"/>
    <p:sldLayoutId id="2147483916" r:id="rId4"/>
    <p:sldLayoutId id="2147483917" r:id="rId5"/>
    <p:sldLayoutId id="2147483918" r:id="rId6"/>
    <p:sldLayoutId id="2147483919" r:id="rId7"/>
    <p:sldLayoutId id="2147483920" r:id="rId8"/>
    <p:sldLayoutId id="2147483921" r:id="rId9"/>
    <p:sldLayoutId id="2147483922" r:id="rId10"/>
    <p:sldLayoutId id="214748392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szatmari.agnes@ttk.hu" TargetMode="Externa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hyperlink" Target="mailto:bozso.zoltan@atk.hu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Diagram 45">
            <a:extLst>
              <a:ext uri="{FF2B5EF4-FFF2-40B4-BE49-F238E27FC236}">
                <a16:creationId xmlns:a16="http://schemas.microsoft.com/office/drawing/2014/main" id="{C9D04A98-1E19-42B2-AD32-1F549F93F1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7924876"/>
              </p:ext>
            </p:extLst>
          </p:nvPr>
        </p:nvGraphicFramePr>
        <p:xfrm>
          <a:off x="1467000" y="4953000"/>
          <a:ext cx="3924000" cy="32558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26A9416D-6F28-49A3-87A5-101321CB597D}"/>
              </a:ext>
            </a:extLst>
          </p:cNvPr>
          <p:cNvSpPr txBox="1"/>
          <p:nvPr/>
        </p:nvSpPr>
        <p:spPr>
          <a:xfrm>
            <a:off x="513567" y="185553"/>
            <a:ext cx="5949864" cy="35721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attern-triggered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mmunity-related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henolic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, acetosyringone,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oosts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rapid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nhibition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of a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iverse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et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of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lant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athogenic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acteria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.</a:t>
            </a:r>
            <a:endParaRPr lang="hu-HU" sz="24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Bef>
                <a:spcPts val="200"/>
              </a:spcBef>
            </a:pPr>
            <a:r>
              <a:rPr lang="en-GB" sz="1300" b="1" dirty="0">
                <a:solidFill>
                  <a:srgbClr val="2E74B5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• Author names and affiliations. </a:t>
            </a:r>
            <a:endParaRPr lang="hu-HU" sz="1300" b="1" dirty="0">
              <a:solidFill>
                <a:srgbClr val="2E74B5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Ágnes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zatmári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c</a:t>
            </a: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, Ágnes M.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óricz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ldikó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hwarczinger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udit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olozsváriné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agy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Ágnes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berti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klós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gány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Zoltán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zsó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ant Protection Institute, ELKH Centre for Agricultural Research, Herman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tó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. 15, 1022 Budapest, Hungary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partment of Pharmacognosy, Faculty of Pharmacy, Semmelweis University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Üllői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. 26, 1085 Budapest, Hungary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esent address: ELKH Research Centre for Natural Sciences, Magyar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dósok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örútj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, 1117, Budapest, Hungary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Corresponding authors’ e-mail addresses: </a:t>
            </a:r>
            <a:r>
              <a:rPr lang="en-GB" sz="12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szatmari.agnes@ttk.hu</a:t>
            </a:r>
            <a:r>
              <a:rPr lang="en-GB" sz="12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bozso.zoltan@atk.hu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C80E2D-55EA-4579-8682-BD59A85CBDDA}"/>
              </a:ext>
            </a:extLst>
          </p:cNvPr>
          <p:cNvSpPr txBox="1"/>
          <p:nvPr/>
        </p:nvSpPr>
        <p:spPr>
          <a:xfrm>
            <a:off x="1467000" y="8419340"/>
            <a:ext cx="3432130" cy="5169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</a:t>
            </a:r>
            <a:r>
              <a:rPr lang="en-GB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.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lative accumulation of AS in </a:t>
            </a:r>
            <a:r>
              <a:rPr lang="en-GB" sz="10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 tabacum</a:t>
            </a:r>
            <a:r>
              <a: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eaves. 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870421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170</Words>
  <Application>Microsoft Office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Ági Szatmári</dc:creator>
  <cp:lastModifiedBy>Ági Szatmári</cp:lastModifiedBy>
  <cp:revision>10</cp:revision>
  <dcterms:created xsi:type="dcterms:W3CDTF">2020-11-22T18:04:44Z</dcterms:created>
  <dcterms:modified xsi:type="dcterms:W3CDTF">2021-02-17T13:39:33Z</dcterms:modified>
</cp:coreProperties>
</file>